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66800"/>
            <a:ext cx="9144000" cy="2286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-15240" y="323604"/>
            <a:ext cx="93025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Gene Ontology: Biological Processes, upregulated genes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-28303" y="3441818"/>
            <a:ext cx="911787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Gene Ontology: Biological Processes, </a:t>
            </a:r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downregulated 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65316"/>
            <a:ext cx="9144000" cy="2286000"/>
          </a:xfrm>
          <a:prstGeom prst="rect">
            <a:avLst/>
          </a:prstGeom>
        </p:spPr>
      </p:pic>
      <p:sp>
        <p:nvSpPr>
          <p:cNvPr id="7" name="TextBox 1"/>
          <p:cNvSpPr txBox="1"/>
          <p:nvPr/>
        </p:nvSpPr>
        <p:spPr>
          <a:xfrm>
            <a:off x="8001000" y="6512200"/>
            <a:ext cx="1077987" cy="345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8247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649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474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298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123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09479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2772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45972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Figure </a:t>
            </a:r>
            <a:r>
              <a:rPr lang="en-US" dirty="0" smtClean="0"/>
              <a:t>S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7176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</TotalTime>
  <Words>1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gdong Wang</dc:creator>
  <cp:lastModifiedBy>Naydenov, Nayden</cp:lastModifiedBy>
  <cp:revision>65</cp:revision>
  <cp:lastPrinted>2019-01-28T20:48:10Z</cp:lastPrinted>
  <dcterms:created xsi:type="dcterms:W3CDTF">2006-08-16T00:00:00Z</dcterms:created>
  <dcterms:modified xsi:type="dcterms:W3CDTF">2019-11-13T22:03:28Z</dcterms:modified>
</cp:coreProperties>
</file>